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5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48"/>
  </p:normalViewPr>
  <p:slideViewPr>
    <p:cSldViewPr snapToGrid="0" snapToObjects="1">
      <p:cViewPr varScale="1">
        <p:scale>
          <a:sx n="117" d="100"/>
          <a:sy n="117" d="100"/>
        </p:scale>
        <p:origin x="36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CA2381-B93E-8F4E-888A-C50198C3E90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1B3E428-8B2C-A647-A48B-6C07272C50E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9A02BA-9DE7-CC43-9ADD-E6AA63118F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A7CB-055B-924B-81A4-11423D16BB4E}" type="datetimeFigureOut">
              <a:rPr lang="en-US" smtClean="0"/>
              <a:t>6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FAD5D9-BA3C-9E44-8DBA-455F1DAB21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274A8C-6EFF-6248-9B7A-1FA860B55A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83B9D-A585-9940-ADA9-4F57F8990A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79703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273901-7BDB-D54D-B6E1-A298ED86B1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0BB2C43-6125-4242-AE8C-ED8A3E0A6D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3F7498-8CEA-094F-B521-8187ECD875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A7CB-055B-924B-81A4-11423D16BB4E}" type="datetimeFigureOut">
              <a:rPr lang="en-US" smtClean="0"/>
              <a:t>6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F58772-9104-4145-AE7E-C023E16267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73AC52-1AC7-DC46-BCC9-3BA120DF7A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83B9D-A585-9940-ADA9-4F57F8990A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47440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929A9C0-E8DC-2F44-B1C8-15CEF5CBA01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E27C18A-9DF1-5745-8AD7-16578F79C7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410CAD-253B-554F-AA02-DD35FD31AF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A7CB-055B-924B-81A4-11423D16BB4E}" type="datetimeFigureOut">
              <a:rPr lang="en-US" smtClean="0"/>
              <a:t>6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3E0DD7-39E9-8F41-B2E5-C6E3625892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91DF60-DB33-5340-BC77-E9126131AD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83B9D-A585-9940-ADA9-4F57F8990A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88055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E1B8B2-DAA6-004F-BF81-9CC504167E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BDFA31-C0CB-004B-B51A-0AD3B73F1E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8E9E08-B9F6-424F-99ED-B19D73D6AA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A7CB-055B-924B-81A4-11423D16BB4E}" type="datetimeFigureOut">
              <a:rPr lang="en-US" smtClean="0"/>
              <a:t>6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16EA94-7DC8-4747-BD9B-16E398812A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5B99C0-DC40-0245-B936-3BF096A20F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83B9D-A585-9940-ADA9-4F57F8990A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3513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8453C1-2EEF-444A-8E80-D3CBAD106E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BA36DB-7B59-6A41-9B1D-B740335C44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803507-CD0F-5B47-90CF-36C77FC3ED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A7CB-055B-924B-81A4-11423D16BB4E}" type="datetimeFigureOut">
              <a:rPr lang="en-US" smtClean="0"/>
              <a:t>6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36C0E0-C039-E94D-A6E4-D664BFD980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9D4B3E-D45D-724F-8B56-10D955E729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83B9D-A585-9940-ADA9-4F57F8990A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45257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4ED74F-55CE-3744-BBB0-5305ECEEA5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F60051B-DC1B-0044-B76A-8280BFA0593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47659B3-1785-F94B-8C61-60EE79F185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60FF7E9-B72F-F142-8C25-5E105BCFAC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A7CB-055B-924B-81A4-11423D16BB4E}" type="datetimeFigureOut">
              <a:rPr lang="en-US" smtClean="0"/>
              <a:t>6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747CF2-EDC3-5E45-9D3A-33390E3A47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36FC02-B952-2A46-BA41-DE80FA113B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83B9D-A585-9940-ADA9-4F57F8990A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11557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A62A5C-4633-1049-9780-A991965CCC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5A0DA5C-19AD-AC42-9660-2BAE21BE3E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C733948-1FC5-6343-95D1-0D309C4AB5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A8A6410-2CEB-0F41-82C9-9E8D5D67F80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C0875DA-686A-1B40-8461-C33918CE8DD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3461726-FC3B-5146-9B0B-3B92468B1D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A7CB-055B-924B-81A4-11423D16BB4E}" type="datetimeFigureOut">
              <a:rPr lang="en-US" smtClean="0"/>
              <a:t>6/26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D00404C-5121-3D48-B196-94189136D8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24B449F-55A3-5F47-A79A-E9559D8D51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83B9D-A585-9940-ADA9-4F57F8990A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45667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33ACF4-8CDC-E24F-9552-969CCCE954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1A7204F-3C03-0144-9684-B1736D6E98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A7CB-055B-924B-81A4-11423D16BB4E}" type="datetimeFigureOut">
              <a:rPr lang="en-US" smtClean="0"/>
              <a:t>6/26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C869DE9-E0C0-274C-A276-98146A4DE6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7979243-5E95-5046-A90B-5CA95A8580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83B9D-A585-9940-ADA9-4F57F8990A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7868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B48AFF9-8BCB-8544-A29C-9B889A22AC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A7CB-055B-924B-81A4-11423D16BB4E}" type="datetimeFigureOut">
              <a:rPr lang="en-US" smtClean="0"/>
              <a:t>6/26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147AA22-D280-8849-89F2-6FE4BBEF04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18F6AAA-E552-6F48-909C-33450DE2D5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83B9D-A585-9940-ADA9-4F57F8990A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39955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4A4D75-75DC-D74A-A76C-E52CF1D2BC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0DFDE4-CC1A-9447-BF77-C82F00ECB21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EA7A758-F7A1-7A45-8312-FB7B416AAF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DD27EA0-6B94-CD4A-9E7F-0D7075F693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A7CB-055B-924B-81A4-11423D16BB4E}" type="datetimeFigureOut">
              <a:rPr lang="en-US" smtClean="0"/>
              <a:t>6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40CFF2-368D-CC43-A65B-085B3C5619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165F2D-9B8F-D042-B6FC-8CA93DC9B4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83B9D-A585-9940-ADA9-4F57F8990A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7894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09ACAF-89FB-3747-B517-EFAE921B7D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FE6A3F0-1167-B84C-B2C7-99F56E08F1D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71EF098-4843-5542-B0BA-B9B536E40F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4F5883A-3B81-3A4F-B41A-2F0953D35F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A7CB-055B-924B-81A4-11423D16BB4E}" type="datetimeFigureOut">
              <a:rPr lang="en-US" smtClean="0"/>
              <a:t>6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7B59F95-AE68-7847-8832-1B939DB3EF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FCB75B-0B47-104C-9F0F-30E7C2023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83B9D-A585-9940-ADA9-4F57F8990A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10213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7158CF6-3265-294F-8BE0-C2A7199A8F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72A8622-8D28-BB4C-959B-2DAAB7DF3A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C174B2-BB60-9C47-AB99-45E9A07A206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6AA7CB-055B-924B-81A4-11423D16BB4E}" type="datetimeFigureOut">
              <a:rPr lang="en-US" smtClean="0"/>
              <a:t>6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F836FA-2AC8-C042-B3F2-504901725CA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B1FE0A-D109-C944-BC20-BDEBA552738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083B9D-A585-9940-ADA9-4F57F8990A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98334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D4911A5-0AEE-AB41-9DDB-CAD8292A039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142" t="8417" r="8913" b="78618"/>
          <a:stretch/>
        </p:blipFill>
        <p:spPr>
          <a:xfrm>
            <a:off x="1128713" y="842963"/>
            <a:ext cx="4350543" cy="442912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23939F78-D231-2942-9F21-6815DA4A2C6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527" t="75365" r="8527" b="8762"/>
          <a:stretch/>
        </p:blipFill>
        <p:spPr>
          <a:xfrm>
            <a:off x="1128713" y="1509823"/>
            <a:ext cx="4350544" cy="54226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7E89866-F480-5B4C-B210-891C926DE7C2}"/>
              </a:ext>
            </a:extLst>
          </p:cNvPr>
          <p:cNvSpPr txBox="1"/>
          <p:nvPr/>
        </p:nvSpPr>
        <p:spPr>
          <a:xfrm>
            <a:off x="364306" y="1596288"/>
            <a:ext cx="7325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Tae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838F092-A3BF-2A4B-964F-8D5FA8A44CFE}"/>
              </a:ext>
            </a:extLst>
          </p:cNvPr>
          <p:cNvSpPr txBox="1"/>
          <p:nvPr/>
        </p:nvSpPr>
        <p:spPr>
          <a:xfrm>
            <a:off x="332407" y="916543"/>
            <a:ext cx="8210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aRNAP</a:t>
            </a:r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2315CC8-92E8-BA43-9AD4-3315D1738456}"/>
              </a:ext>
            </a:extLst>
          </p:cNvPr>
          <p:cNvSpPr txBox="1"/>
          <p:nvPr/>
        </p:nvSpPr>
        <p:spPr>
          <a:xfrm>
            <a:off x="1096814" y="2082579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C57AD9F-63DD-BC46-B297-8E4CE3C038B0}"/>
              </a:ext>
            </a:extLst>
          </p:cNvPr>
          <p:cNvSpPr txBox="1"/>
          <p:nvPr/>
        </p:nvSpPr>
        <p:spPr>
          <a:xfrm>
            <a:off x="1819601" y="2082579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58A5759-B050-4A4A-ADD6-8F9A3A73265D}"/>
              </a:ext>
            </a:extLst>
          </p:cNvPr>
          <p:cNvSpPr txBox="1"/>
          <p:nvPr/>
        </p:nvSpPr>
        <p:spPr>
          <a:xfrm>
            <a:off x="2446691" y="2082579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0D55FB3-D4C0-5146-A5B9-292EC8C1C495}"/>
              </a:ext>
            </a:extLst>
          </p:cNvPr>
          <p:cNvSpPr txBox="1"/>
          <p:nvPr/>
        </p:nvSpPr>
        <p:spPr>
          <a:xfrm>
            <a:off x="3148212" y="2082579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4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12B90CF-D1F9-D04D-B3B7-5F6754A744DA}"/>
              </a:ext>
            </a:extLst>
          </p:cNvPr>
          <p:cNvSpPr txBox="1"/>
          <p:nvPr/>
        </p:nvSpPr>
        <p:spPr>
          <a:xfrm>
            <a:off x="3817057" y="2082579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416A7EC-918A-1344-9F19-CB74378081E1}"/>
              </a:ext>
            </a:extLst>
          </p:cNvPr>
          <p:cNvSpPr txBox="1"/>
          <p:nvPr/>
        </p:nvSpPr>
        <p:spPr>
          <a:xfrm>
            <a:off x="4454782" y="2082579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A3064A2-20AB-8448-AEE3-32800B45D57A}"/>
              </a:ext>
            </a:extLst>
          </p:cNvPr>
          <p:cNvSpPr txBox="1"/>
          <p:nvPr/>
        </p:nvSpPr>
        <p:spPr>
          <a:xfrm>
            <a:off x="5177570" y="2082579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689EE68-72EF-DB4C-8AD7-C5C8950376AE}"/>
              </a:ext>
            </a:extLst>
          </p:cNvPr>
          <p:cNvSpPr txBox="1"/>
          <p:nvPr/>
        </p:nvSpPr>
        <p:spPr>
          <a:xfrm>
            <a:off x="905255" y="2818295"/>
            <a:ext cx="1165704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 – vector</a:t>
            </a:r>
          </a:p>
          <a:p>
            <a:r>
              <a:rPr lang="en-US" dirty="0"/>
              <a:t>2 – WT</a:t>
            </a:r>
          </a:p>
          <a:p>
            <a:r>
              <a:rPr lang="en-US" dirty="0"/>
              <a:t>3 – C30A</a:t>
            </a:r>
          </a:p>
          <a:p>
            <a:r>
              <a:rPr lang="en-US" dirty="0"/>
              <a:t>4 – C110S</a:t>
            </a:r>
          </a:p>
          <a:p>
            <a:r>
              <a:rPr lang="en-US" dirty="0"/>
              <a:t>5 – A116T</a:t>
            </a:r>
          </a:p>
          <a:p>
            <a:r>
              <a:rPr lang="en-US" dirty="0"/>
              <a:t>6 – D134N</a:t>
            </a:r>
          </a:p>
          <a:p>
            <a:r>
              <a:rPr lang="en-US" dirty="0"/>
              <a:t>7 – S147I 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34FBE2D-99AF-994D-A547-62A665FC25B2}"/>
              </a:ext>
            </a:extLst>
          </p:cNvPr>
          <p:cNvSpPr txBox="1"/>
          <p:nvPr/>
        </p:nvSpPr>
        <p:spPr>
          <a:xfrm>
            <a:off x="4118743" y="5348177"/>
            <a:ext cx="204665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WB - lysis assays in </a:t>
            </a:r>
          </a:p>
          <a:p>
            <a:r>
              <a:rPr lang="en-US" b="1" dirty="0"/>
              <a:t>D-Met media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4DDF1F68-7A9F-C648-9933-2924A39DFA7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598389" y="680985"/>
            <a:ext cx="3548020" cy="2199938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4992E14F-956A-8843-A35F-47B73B1B5D7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30716" y="3394726"/>
            <a:ext cx="3415693" cy="2224749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D3AC6578-D154-2D41-A623-FC405BC5CFE6}"/>
              </a:ext>
            </a:extLst>
          </p:cNvPr>
          <p:cNvSpPr txBox="1"/>
          <p:nvPr/>
        </p:nvSpPr>
        <p:spPr>
          <a:xfrm>
            <a:off x="7220511" y="1319289"/>
            <a:ext cx="137787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aw images:</a:t>
            </a:r>
          </a:p>
          <a:p>
            <a:r>
              <a:rPr lang="en-US" dirty="0"/>
              <a:t>-MW marker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00D4377-B238-944C-BC62-4C53948CAC96}"/>
              </a:ext>
            </a:extLst>
          </p:cNvPr>
          <p:cNvSpPr txBox="1"/>
          <p:nvPr/>
        </p:nvSpPr>
        <p:spPr>
          <a:xfrm>
            <a:off x="7223819" y="4155618"/>
            <a:ext cx="137787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aw images:</a:t>
            </a:r>
          </a:p>
          <a:p>
            <a:r>
              <a:rPr lang="en-US" dirty="0"/>
              <a:t>-WB</a:t>
            </a:r>
          </a:p>
        </p:txBody>
      </p:sp>
    </p:spTree>
    <p:extLst>
      <p:ext uri="{BB962C8B-B14F-4D97-AF65-F5344CB8AC3E}">
        <p14:creationId xmlns:p14="http://schemas.microsoft.com/office/powerpoint/2010/main" val="3312363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6D9477A-D233-656A-24C6-20DD7B12DBDF}"/>
              </a:ext>
            </a:extLst>
          </p:cNvPr>
          <p:cNvSpPr txBox="1"/>
          <p:nvPr/>
        </p:nvSpPr>
        <p:spPr>
          <a:xfrm>
            <a:off x="9354772" y="5838034"/>
            <a:ext cx="204665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WB - lysis assays in </a:t>
            </a:r>
          </a:p>
          <a:p>
            <a:r>
              <a:rPr lang="en-US" b="1" dirty="0"/>
              <a:t>plain media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8F1AA06-E08B-363B-1BB7-6313A8509F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28699" y="231321"/>
            <a:ext cx="5655129" cy="46346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162807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0</TotalTime>
  <Words>55</Words>
  <Application>Microsoft Macintosh PowerPoint</Application>
  <PresentationFormat>Widescreen</PresentationFormat>
  <Paragraphs>2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dkov, Atanas</dc:creator>
  <cp:lastModifiedBy>Radkov, Atanas</cp:lastModifiedBy>
  <cp:revision>40</cp:revision>
  <dcterms:created xsi:type="dcterms:W3CDTF">2022-04-10T22:33:40Z</dcterms:created>
  <dcterms:modified xsi:type="dcterms:W3CDTF">2022-06-26T18:07:34Z</dcterms:modified>
</cp:coreProperties>
</file>